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44" autoAdjust="0"/>
    <p:restoredTop sz="94660"/>
  </p:normalViewPr>
  <p:slideViewPr>
    <p:cSldViewPr snapToGrid="0">
      <p:cViewPr varScale="1">
        <p:scale>
          <a:sx n="70" d="100"/>
          <a:sy n="70" d="100"/>
        </p:scale>
        <p:origin x="654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28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4FD-4B74-A5D2-7E35C5444A34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4FD-4B74-A5D2-7E35C5444A34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4FD-4B74-A5D2-7E35C5444A34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44FD-4B74-A5D2-7E35C5444A34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44FD-4B74-A5D2-7E35C5444A34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44FD-4B74-A5D2-7E35C5444A34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44FD-4B74-A5D2-7E35C5444A34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44FD-4B74-A5D2-7E35C5444A34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44FD-4B74-A5D2-7E35C5444A34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3-44FD-4B74-A5D2-7E35C5444A34}"/>
              </c:ext>
            </c:extLst>
          </c:dPt>
          <c:dLbls>
            <c:dLbl>
              <c:idx val="1"/>
              <c:layout>
                <c:manualLayout>
                  <c:x val="2.5000000000000001E-2"/>
                  <c:y val="-1.4062499134934847E-2"/>
                </c:manualLayout>
              </c:layout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separator>
</c:separator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3-44FD-4B74-A5D2-7E35C5444A34}"/>
                </c:ext>
              </c:extLst>
            </c:dLbl>
            <c:dLbl>
              <c:idx val="6"/>
              <c:layout>
                <c:manualLayout>
                  <c:x val="-1.1458200967217994E-16"/>
                  <c:y val="3.7499997693159592E-2"/>
                </c:manualLayout>
              </c:layout>
              <c:dLblPos val="bestFit"/>
              <c:showLegendKey val="0"/>
              <c:showVal val="1"/>
              <c:showCatName val="1"/>
              <c:showSerName val="0"/>
              <c:showPercent val="0"/>
              <c:showBubbleSize val="0"/>
              <c:separator>
</c:separator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D-44FD-4B74-A5D2-7E35C5444A34}"/>
                </c:ext>
              </c:extLst>
            </c:dLbl>
            <c:spPr>
              <a:solidFill>
                <a:prstClr val="white"/>
              </a:solidFill>
              <a:ln>
                <a:solidFill>
                  <a:prstClr val="black">
                    <a:lumMod val="25000"/>
                    <a:lumOff val="75000"/>
                  </a:prstClr>
                </a:solidFill>
              </a:ln>
              <a:effectLst/>
            </c:spPr>
            <c:txPr>
              <a:bodyPr rot="0" spcFirstLastPara="1" vertOverflow="clip" horzOverflow="clip" vert="horz" wrap="square" lIns="38100" tIns="19050" rIns="38100" bIns="19050" anchor="ctr" anchorCtr="1">
                <a:spAutoFit/>
              </a:bodyPr>
              <a:lstStyle/>
              <a:p>
                <a:pPr>
                  <a:defRPr sz="1197" b="0" i="0" u="none" strike="noStrike" kern="1200" baseline="0">
                    <a:solidFill>
                      <a:schemeClr val="dk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1"/>
            <c:showSerName val="0"/>
            <c:showPercent val="0"/>
            <c:showBubbleSize val="0"/>
            <c:separator>
</c:separator>
            <c:showLeaderLines val="0"/>
            <c:extLst>
              <c:ext xmlns:c15="http://schemas.microsoft.com/office/drawing/2012/chart" uri="{CE6537A1-D6FC-4f65-9D91-7224C49458BB}">
                <c15:spPr xmlns:c15="http://schemas.microsoft.com/office/drawing/2012/chart">
                  <a:prstGeom prst="wedgeRectCallout">
                    <a:avLst/>
                  </a:prstGeom>
                  <a:noFill/>
                  <a:ln>
                    <a:noFill/>
                  </a:ln>
                </c15:spPr>
                <c15:layout/>
              </c:ext>
            </c:extLst>
          </c:dLbls>
          <c:cat>
            <c:strRef>
              <c:f>Sheet1!$A$2:$A$11</c:f>
              <c:strCache>
                <c:ptCount val="10"/>
                <c:pt idx="0">
                  <c:v>Transcription and translation</c:v>
                </c:pt>
                <c:pt idx="1">
                  <c:v>Primary metabolism and storage</c:v>
                </c:pt>
                <c:pt idx="2">
                  <c:v>Transposable elements</c:v>
                </c:pt>
                <c:pt idx="3">
                  <c:v>Protein processing</c:v>
                </c:pt>
                <c:pt idx="4">
                  <c:v>Secondary metabolism</c:v>
                </c:pt>
                <c:pt idx="5">
                  <c:v>Stress response</c:v>
                </c:pt>
                <c:pt idx="6">
                  <c:v>Signaling</c:v>
                </c:pt>
                <c:pt idx="7">
                  <c:v>Other functions</c:v>
                </c:pt>
                <c:pt idx="8">
                  <c:v>Uncharacterized proteins</c:v>
                </c:pt>
                <c:pt idx="9">
                  <c:v>No match to databases</c:v>
                </c:pt>
              </c:strCache>
            </c:strRef>
          </c:cat>
          <c:val>
            <c:numRef>
              <c:f>Sheet1!$B$2:$B$11</c:f>
              <c:numCache>
                <c:formatCode>General</c:formatCode>
                <c:ptCount val="10"/>
                <c:pt idx="0">
                  <c:v>14</c:v>
                </c:pt>
                <c:pt idx="1">
                  <c:v>13</c:v>
                </c:pt>
                <c:pt idx="2">
                  <c:v>10</c:v>
                </c:pt>
                <c:pt idx="3">
                  <c:v>8</c:v>
                </c:pt>
                <c:pt idx="4">
                  <c:v>8</c:v>
                </c:pt>
                <c:pt idx="5">
                  <c:v>6</c:v>
                </c:pt>
                <c:pt idx="6">
                  <c:v>4</c:v>
                </c:pt>
                <c:pt idx="7">
                  <c:v>25</c:v>
                </c:pt>
                <c:pt idx="8">
                  <c:v>32</c:v>
                </c:pt>
                <c:pt idx="9">
                  <c:v>1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44FD-4B74-A5D2-7E35C5444A34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0"/>
        </c:dLbls>
        <c:firstSliceAng val="0"/>
      </c:pieChart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684AD-442F-470E-A6F9-40FC9E8E3A48}" type="datetimeFigureOut">
              <a:rPr lang="en-CA" smtClean="0"/>
              <a:t>2021-09-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1ED86-2729-4757-9D9B-66BEA3302B9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02129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684AD-442F-470E-A6F9-40FC9E8E3A48}" type="datetimeFigureOut">
              <a:rPr lang="en-CA" smtClean="0"/>
              <a:t>2021-09-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1ED86-2729-4757-9D9B-66BEA3302B9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574573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684AD-442F-470E-A6F9-40FC9E8E3A48}" type="datetimeFigureOut">
              <a:rPr lang="en-CA" smtClean="0"/>
              <a:t>2021-09-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1ED86-2729-4757-9D9B-66BEA3302B9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69243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684AD-442F-470E-A6F9-40FC9E8E3A48}" type="datetimeFigureOut">
              <a:rPr lang="en-CA" smtClean="0"/>
              <a:t>2021-09-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1ED86-2729-4757-9D9B-66BEA3302B9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965132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684AD-442F-470E-A6F9-40FC9E8E3A48}" type="datetimeFigureOut">
              <a:rPr lang="en-CA" smtClean="0"/>
              <a:t>2021-09-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1ED86-2729-4757-9D9B-66BEA3302B9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819344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684AD-442F-470E-A6F9-40FC9E8E3A48}" type="datetimeFigureOut">
              <a:rPr lang="en-CA" smtClean="0"/>
              <a:t>2021-09-1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1ED86-2729-4757-9D9B-66BEA3302B9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914858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684AD-442F-470E-A6F9-40FC9E8E3A48}" type="datetimeFigureOut">
              <a:rPr lang="en-CA" smtClean="0"/>
              <a:t>2021-09-14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1ED86-2729-4757-9D9B-66BEA3302B9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328876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684AD-442F-470E-A6F9-40FC9E8E3A48}" type="datetimeFigureOut">
              <a:rPr lang="en-CA" smtClean="0"/>
              <a:t>2021-09-14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1ED86-2729-4757-9D9B-66BEA3302B9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250929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684AD-442F-470E-A6F9-40FC9E8E3A48}" type="datetimeFigureOut">
              <a:rPr lang="en-CA" smtClean="0"/>
              <a:t>2021-09-14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1ED86-2729-4757-9D9B-66BEA3302B9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846101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684AD-442F-470E-A6F9-40FC9E8E3A48}" type="datetimeFigureOut">
              <a:rPr lang="en-CA" smtClean="0"/>
              <a:t>2021-09-1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1ED86-2729-4757-9D9B-66BEA3302B9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835821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7684AD-442F-470E-A6F9-40FC9E8E3A48}" type="datetimeFigureOut">
              <a:rPr lang="en-CA" smtClean="0"/>
              <a:t>2021-09-1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41ED86-2729-4757-9D9B-66BEA3302B9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702440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7684AD-442F-470E-A6F9-40FC9E8E3A48}" type="datetimeFigureOut">
              <a:rPr lang="en-CA" smtClean="0"/>
              <a:t>2021-09-1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41ED86-2729-4757-9D9B-66BEA3302B9A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8027148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/>
          <p:cNvGraphicFramePr/>
          <p:nvPr>
            <p:extLst>
              <p:ext uri="{D42A27DB-BD31-4B8C-83A1-F6EECF244321}">
                <p14:modId xmlns:p14="http://schemas.microsoft.com/office/powerpoint/2010/main" val="3550105632"/>
              </p:ext>
            </p:extLst>
          </p:nvPr>
        </p:nvGraphicFramePr>
        <p:xfrm>
          <a:off x="2106468" y="281613"/>
          <a:ext cx="8128000" cy="54186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636323" y="5715003"/>
            <a:ext cx="1121228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le 9. (.TIF file) Pie chart representing the functional categorization of wheat transcripts differentially expressed in water-treated rachis samples between CS and CS-7EL</a:t>
            </a:r>
            <a:r>
              <a:rPr lang="en-US" dirty="0" smtClean="0"/>
              <a:t>.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30432691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4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erese</dc:creator>
  <cp:lastModifiedBy>Ouellet, Thérèse</cp:lastModifiedBy>
  <cp:revision>5</cp:revision>
  <dcterms:created xsi:type="dcterms:W3CDTF">2021-02-17T19:38:33Z</dcterms:created>
  <dcterms:modified xsi:type="dcterms:W3CDTF">2021-09-14T15:08:37Z</dcterms:modified>
</cp:coreProperties>
</file>